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78" y="16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C91ED-8EC5-46D5-8ACA-8AE2A1AF24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76A5A1-061E-40FA-8063-95B058BA64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C084BB-1501-4823-B5F3-8C3D31BF1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D2F59-4A5A-4827-88B9-46ED26B9D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0D80E-A6BF-473C-A651-5D6B9C716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689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12FBFE-FAED-494B-919C-41E2D9325E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3C434B-655C-4F67-859A-C09F300792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E7B8E-8090-4CD9-903C-173EBDB14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2D5E21-D5C8-4764-AB75-DD9A36414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938BF-91E5-4556-AFEE-C476E0A82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722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FEB91D-42F9-4CB8-B4E9-03EAE007A1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8AE0F1-FDA5-4B0C-9C92-F8E0A0A8F3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0152E6-05A8-4429-8661-926137115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313A16-31BC-41DE-A19B-A9E483549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46170E-F363-4FEA-8DE1-6C03FC411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306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9E34DA-0826-4028-AB23-BAC9213750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50242C-0906-4A04-9D5F-603A8EA706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B550FB-F28D-44CC-B00E-856C329AD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1986E2-5D01-480D-B413-ACDF0700F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AE5356-E085-4059-AF2D-DCE547AB6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17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88275E-6B80-4C0A-A66C-4E5AD696AC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98AAE4-5ADC-4C88-A343-04555B071B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1C632-6C0C-4277-BB5B-5EF0B3B43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9C04C5-EBD1-4A4B-B616-2F61D895C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68ECD-C6C4-422C-A119-3B1F502FC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858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2BA4D5-71B9-4A0B-AB67-D0EDE59168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3FC9A5-0306-471D-87AB-A518D1333C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8D3554-FA80-4895-AE18-5942CE2CA7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83AEA8-681F-4A99-BE95-61B9DFE74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A0F4CB-E5BB-4B51-938C-D505AD86F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CF1A5-F741-43B0-8715-047CE1874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826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DF6D6B-4745-422B-8727-D3DC5F969F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25350E-5178-4FD0-BFC1-84491E3A3E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E6F654-B8CD-42C3-AAC9-D237A11573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BAE071-F7FD-483F-8843-3D83569F07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AE34A7-1CE7-40A7-A72E-77C28D8033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E7CFA0-EB01-4A67-A0AA-C279DDA8B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5091C7-AD2A-4855-87B3-492ED0E55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D735C4-FAEC-4B54-BF56-F8723B0D8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712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9CBD7-6857-4DD3-9286-32B400949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A2564A-B4C5-42DD-B0BE-327EF3670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FB3EDA-864D-40E5-A414-F5676FF63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AC725F-8154-4962-998E-3E7FEBC1A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03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62C4F0-D837-4D09-8487-792D50BAB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94AC3E-1569-43FC-A9B8-CD1488421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4F5580-2BB3-4208-94AA-D1BD616A7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210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6F7C1-06C0-48B4-B32A-3245D27B3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4B4059-7AF8-4EAB-9A23-9FD23FBFB2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C25027-36C1-400D-9E71-23B8089559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E0CDBF-19DD-45B4-B710-E31124D7D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F72873-BE21-4913-9045-40B5C5CE1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DC2557-AB50-4BE4-AB12-B44EEAE64B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48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96597-1B5D-4EDD-BCA5-2F55C1C45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DB7A72-B1F6-4087-9E4D-6EFBC45BFA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ADD10B-B7B9-4320-8134-A122C7F905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A69FE1-4403-4E68-BC35-ED190DC20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A29831-693F-48FF-AD35-97DBF9F32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400CCF-EEC6-46A6-BF6D-8E9B9AC3F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59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729326-715C-4382-86DA-C9D8F484D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A0FEF0-022C-40C8-A44C-CC782B33F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67076-C687-4997-ACD7-CB5544B97D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27D84D-47DC-4AB1-BE6D-BD98D441AE72}" type="datetimeFigureOut">
              <a:rPr lang="en-US" smtClean="0"/>
              <a:t>4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5CAA11-8E45-4136-A6E3-AC62519473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06569E-5BD3-4812-89F0-B57D6354A7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A0A23C-B5E3-40E0-9570-FCE59A0E8F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502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CCEB71F-37E2-4AA6-BD01-7EE325F5B0E2}"/>
              </a:ext>
            </a:extLst>
          </p:cNvPr>
          <p:cNvSpPr txBox="1"/>
          <p:nvPr/>
        </p:nvSpPr>
        <p:spPr>
          <a:xfrm>
            <a:off x="323199" y="204305"/>
            <a:ext cx="1047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7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549329C-8C3A-4A89-A62F-7408AE6BE4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034" y="877373"/>
            <a:ext cx="4171240" cy="42201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D6351FC-EC8D-4C2C-A7C1-1A5A82515FEE}"/>
              </a:ext>
            </a:extLst>
          </p:cNvPr>
          <p:cNvSpPr txBox="1"/>
          <p:nvPr/>
        </p:nvSpPr>
        <p:spPr>
          <a:xfrm>
            <a:off x="2510623" y="1220513"/>
            <a:ext cx="6801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a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45134D-BF46-4BB0-92C6-800EE9F1A0C6}"/>
              </a:ext>
            </a:extLst>
          </p:cNvPr>
          <p:cNvSpPr txBox="1"/>
          <p:nvPr/>
        </p:nvSpPr>
        <p:spPr>
          <a:xfrm>
            <a:off x="2634360" y="3403396"/>
            <a:ext cx="80220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l30 (m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C3023B-B029-49F8-8453-DD8A8C049D2B}"/>
              </a:ext>
            </a:extLst>
          </p:cNvPr>
          <p:cNvSpPr txBox="1"/>
          <p:nvPr/>
        </p:nvSpPr>
        <p:spPr>
          <a:xfrm>
            <a:off x="1555211" y="2406985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DCAAB27-D91D-43F5-9CAA-D146107D233A}"/>
              </a:ext>
            </a:extLst>
          </p:cNvPr>
          <p:cNvSpPr txBox="1"/>
          <p:nvPr/>
        </p:nvSpPr>
        <p:spPr>
          <a:xfrm>
            <a:off x="1938136" y="2406985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01FA960-222A-449B-B208-6F5CB10F8539}"/>
              </a:ext>
            </a:extLst>
          </p:cNvPr>
          <p:cNvSpPr txBox="1"/>
          <p:nvPr/>
        </p:nvSpPr>
        <p:spPr>
          <a:xfrm>
            <a:off x="1746673" y="2424626"/>
            <a:ext cx="346249" cy="8198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3C61B8E-D28B-4BC3-9660-447653394437}"/>
              </a:ext>
            </a:extLst>
          </p:cNvPr>
          <p:cNvSpPr txBox="1"/>
          <p:nvPr/>
        </p:nvSpPr>
        <p:spPr>
          <a:xfrm>
            <a:off x="1363749" y="2412709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B110D4-7F0A-4A40-9E9E-E640069F0C75}"/>
              </a:ext>
            </a:extLst>
          </p:cNvPr>
          <p:cNvSpPr txBox="1"/>
          <p:nvPr/>
        </p:nvSpPr>
        <p:spPr>
          <a:xfrm>
            <a:off x="2672902" y="2374688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F58A4B-4961-432E-8656-C52969DC50E4}"/>
              </a:ext>
            </a:extLst>
          </p:cNvPr>
          <p:cNvSpPr txBox="1"/>
          <p:nvPr/>
        </p:nvSpPr>
        <p:spPr>
          <a:xfrm>
            <a:off x="3055827" y="2374688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8BE3E03-5312-40B0-95A6-A4CB2AFAAB68}"/>
              </a:ext>
            </a:extLst>
          </p:cNvPr>
          <p:cNvSpPr txBox="1"/>
          <p:nvPr/>
        </p:nvSpPr>
        <p:spPr>
          <a:xfrm>
            <a:off x="2864364" y="2392329"/>
            <a:ext cx="346249" cy="8198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5B0E377-379F-42CA-8326-29597E7BFFE6}"/>
              </a:ext>
            </a:extLst>
          </p:cNvPr>
          <p:cNvSpPr txBox="1"/>
          <p:nvPr/>
        </p:nvSpPr>
        <p:spPr>
          <a:xfrm>
            <a:off x="2481440" y="2380412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0D16BDD-B6ED-458B-9D1F-E5671403D944}"/>
              </a:ext>
            </a:extLst>
          </p:cNvPr>
          <p:cNvSpPr txBox="1"/>
          <p:nvPr/>
        </p:nvSpPr>
        <p:spPr>
          <a:xfrm>
            <a:off x="3779254" y="2308663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37053D-E64E-4761-940E-7D51B0B4A49D}"/>
              </a:ext>
            </a:extLst>
          </p:cNvPr>
          <p:cNvSpPr txBox="1"/>
          <p:nvPr/>
        </p:nvSpPr>
        <p:spPr>
          <a:xfrm>
            <a:off x="4162179" y="2308663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F6C9B58-0649-4F7F-8702-D5356205AB55}"/>
              </a:ext>
            </a:extLst>
          </p:cNvPr>
          <p:cNvSpPr txBox="1"/>
          <p:nvPr/>
        </p:nvSpPr>
        <p:spPr>
          <a:xfrm>
            <a:off x="3970716" y="2326304"/>
            <a:ext cx="346249" cy="8198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4E7DA9-98A9-483C-A314-58417AA4A5F2}"/>
              </a:ext>
            </a:extLst>
          </p:cNvPr>
          <p:cNvSpPr txBox="1"/>
          <p:nvPr/>
        </p:nvSpPr>
        <p:spPr>
          <a:xfrm>
            <a:off x="3587792" y="2314387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96432B-8875-488E-8689-7A98D916302D}"/>
              </a:ext>
            </a:extLst>
          </p:cNvPr>
          <p:cNvSpPr txBox="1"/>
          <p:nvPr/>
        </p:nvSpPr>
        <p:spPr>
          <a:xfrm>
            <a:off x="1479860" y="4279123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E32693C-7193-490F-8767-E5FAD77B2B13}"/>
              </a:ext>
            </a:extLst>
          </p:cNvPr>
          <p:cNvSpPr txBox="1"/>
          <p:nvPr/>
        </p:nvSpPr>
        <p:spPr>
          <a:xfrm>
            <a:off x="1862785" y="4279123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A678213-1B94-4E53-840D-5EA0183C3C6F}"/>
              </a:ext>
            </a:extLst>
          </p:cNvPr>
          <p:cNvSpPr txBox="1"/>
          <p:nvPr/>
        </p:nvSpPr>
        <p:spPr>
          <a:xfrm>
            <a:off x="1671322" y="4296764"/>
            <a:ext cx="346249" cy="8198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F4FCCBC-9127-49B4-A658-3873BF69D1F3}"/>
              </a:ext>
            </a:extLst>
          </p:cNvPr>
          <p:cNvSpPr txBox="1"/>
          <p:nvPr/>
        </p:nvSpPr>
        <p:spPr>
          <a:xfrm>
            <a:off x="1288398" y="4284847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5E6B459-7237-41E4-93AD-D27F2621FD78}"/>
              </a:ext>
            </a:extLst>
          </p:cNvPr>
          <p:cNvSpPr txBox="1"/>
          <p:nvPr/>
        </p:nvSpPr>
        <p:spPr>
          <a:xfrm>
            <a:off x="2654563" y="4221729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E085DA9-71ED-41DA-B8A8-7CC3AF5D724E}"/>
              </a:ext>
            </a:extLst>
          </p:cNvPr>
          <p:cNvSpPr txBox="1"/>
          <p:nvPr/>
        </p:nvSpPr>
        <p:spPr>
          <a:xfrm>
            <a:off x="3037488" y="4221729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BP1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E09C61D-4D95-4FA7-9540-698146186B7A}"/>
              </a:ext>
            </a:extLst>
          </p:cNvPr>
          <p:cNvSpPr txBox="1"/>
          <p:nvPr/>
        </p:nvSpPr>
        <p:spPr>
          <a:xfrm>
            <a:off x="2846025" y="4239370"/>
            <a:ext cx="346249" cy="81980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IgG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C53F2EB-E27A-438A-8759-14A63088BAE6}"/>
              </a:ext>
            </a:extLst>
          </p:cNvPr>
          <p:cNvSpPr txBox="1"/>
          <p:nvPr/>
        </p:nvSpPr>
        <p:spPr>
          <a:xfrm>
            <a:off x="2463101" y="4227453"/>
            <a:ext cx="346249" cy="66331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7D1C22B-A402-4326-B146-BA5E69C6E793}"/>
              </a:ext>
            </a:extLst>
          </p:cNvPr>
          <p:cNvSpPr txBox="1"/>
          <p:nvPr/>
        </p:nvSpPr>
        <p:spPr>
          <a:xfrm>
            <a:off x="3241543" y="4221729"/>
            <a:ext cx="346249" cy="78934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ne H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FD8F29A-E07F-4E5C-9CCA-269998EDC613}"/>
              </a:ext>
            </a:extLst>
          </p:cNvPr>
          <p:cNvSpPr txBox="1"/>
          <p:nvPr/>
        </p:nvSpPr>
        <p:spPr>
          <a:xfrm>
            <a:off x="846740" y="2243843"/>
            <a:ext cx="40532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bp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8EE4A797-1396-4E62-893E-390557527229}"/>
              </a:ext>
            </a:extLst>
          </p:cNvPr>
          <p:cNvCxnSpPr>
            <a:cxnSpLocks/>
          </p:cNvCxnSpPr>
          <p:nvPr/>
        </p:nvCxnSpPr>
        <p:spPr>
          <a:xfrm>
            <a:off x="1033793" y="2263492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12F6E8F-2BB1-403F-8494-976D1C46762C}"/>
              </a:ext>
            </a:extLst>
          </p:cNvPr>
          <p:cNvSpPr txBox="1"/>
          <p:nvPr/>
        </p:nvSpPr>
        <p:spPr>
          <a:xfrm>
            <a:off x="829137" y="4205211"/>
            <a:ext cx="40532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bp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D412DA6F-B4E0-47E1-8194-15C8860021BD}"/>
              </a:ext>
            </a:extLst>
          </p:cNvPr>
          <p:cNvCxnSpPr>
            <a:cxnSpLocks/>
          </p:cNvCxnSpPr>
          <p:nvPr/>
        </p:nvCxnSpPr>
        <p:spPr>
          <a:xfrm>
            <a:off x="1008817" y="4224861"/>
            <a:ext cx="18302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8A0F2C20-A49F-440B-B4D6-1FC65B9EC7D8}"/>
              </a:ext>
            </a:extLst>
          </p:cNvPr>
          <p:cNvSpPr txBox="1"/>
          <p:nvPr/>
        </p:nvSpPr>
        <p:spPr>
          <a:xfrm>
            <a:off x="1431145" y="1256884"/>
            <a:ext cx="6801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jb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FD7935D-379D-4D9D-9461-BECAEDD9129D}"/>
              </a:ext>
            </a:extLst>
          </p:cNvPr>
          <p:cNvSpPr txBox="1"/>
          <p:nvPr/>
        </p:nvSpPr>
        <p:spPr>
          <a:xfrm>
            <a:off x="3706225" y="1220513"/>
            <a:ext cx="802203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mk Binding Site 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32FF5EF-540B-4F24-806A-BECF0DE99732}"/>
              </a:ext>
            </a:extLst>
          </p:cNvPr>
          <p:cNvSpPr txBox="1"/>
          <p:nvPr/>
        </p:nvSpPr>
        <p:spPr>
          <a:xfrm>
            <a:off x="1365237" y="3227557"/>
            <a:ext cx="802203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mk Binding Site 2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71609AF-7BCF-42C7-9574-3FEE2DC0EC71}"/>
              </a:ext>
            </a:extLst>
          </p:cNvPr>
          <p:cNvSpPr/>
          <p:nvPr/>
        </p:nvSpPr>
        <p:spPr>
          <a:xfrm>
            <a:off x="3868217" y="2044700"/>
            <a:ext cx="612192" cy="241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7684875A-3FE0-4DB9-8318-E3B2B34D842E}"/>
              </a:ext>
            </a:extLst>
          </p:cNvPr>
          <p:cNvSpPr/>
          <p:nvPr/>
        </p:nvSpPr>
        <p:spPr>
          <a:xfrm>
            <a:off x="2771545" y="2044700"/>
            <a:ext cx="612192" cy="241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A834CFA-0837-4739-A90D-4660D453C1CB}"/>
              </a:ext>
            </a:extLst>
          </p:cNvPr>
          <p:cNvSpPr/>
          <p:nvPr/>
        </p:nvSpPr>
        <p:spPr>
          <a:xfrm>
            <a:off x="1619255" y="2111290"/>
            <a:ext cx="612192" cy="241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16F75EE-9035-41E9-B6B9-D71CFD9BC224}"/>
              </a:ext>
            </a:extLst>
          </p:cNvPr>
          <p:cNvSpPr/>
          <p:nvPr/>
        </p:nvSpPr>
        <p:spPr>
          <a:xfrm>
            <a:off x="2718337" y="3974917"/>
            <a:ext cx="814827" cy="241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39616C7-7379-4F1B-8FDC-104BE4637EEA}"/>
              </a:ext>
            </a:extLst>
          </p:cNvPr>
          <p:cNvSpPr/>
          <p:nvPr/>
        </p:nvSpPr>
        <p:spPr>
          <a:xfrm>
            <a:off x="1567006" y="4055326"/>
            <a:ext cx="612192" cy="2410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59434897-BD5B-4703-88FB-67FFE3049ABB}"/>
              </a:ext>
            </a:extLst>
          </p:cNvPr>
          <p:cNvSpPr/>
          <p:nvPr/>
        </p:nvSpPr>
        <p:spPr>
          <a:xfrm>
            <a:off x="5267664" y="1559384"/>
            <a:ext cx="1031535" cy="396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pped images</a:t>
            </a:r>
          </a:p>
        </p:txBody>
      </p:sp>
    </p:spTree>
    <p:extLst>
      <p:ext uri="{BB962C8B-B14F-4D97-AF65-F5344CB8AC3E}">
        <p14:creationId xmlns:p14="http://schemas.microsoft.com/office/powerpoint/2010/main" val="280203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9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1</cp:revision>
  <dcterms:created xsi:type="dcterms:W3CDTF">2024-04-16T17:41:36Z</dcterms:created>
  <dcterms:modified xsi:type="dcterms:W3CDTF">2024-04-16T17:43:48Z</dcterms:modified>
</cp:coreProperties>
</file>